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618E3C-8713-4654-A9BD-DB81CF214D15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74CA4B-4D65-43EC-B4B2-9E1E993D8DB7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73E8F-52BA-4765-B717-42FF0521DF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47F21-E349-46E8-A862-FEF5D36224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B1F53-4AF7-4484-B956-98F228EFF3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06BC1-15B8-4C22-9A22-6ED86440C8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103AB-0EF4-40A3-956B-A6F0DB2E9E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21504-ECC4-4302-86F8-51E8D2ED6E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F3307-0625-46AE-8070-7AD8A294E1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92FFA-BB7C-4CBB-8578-C8B0DC736A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BF55B-A6FE-481F-B3DB-1E48C40296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A4D80-5B4B-465C-B3C8-CBE0E4D687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E81D9-54C8-4152-914D-741D252734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696EB-2451-4096-9D88-E7CCF96A7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0AA27E-1765-4FA9-8AF4-1243D9EB8A08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Image 1" descr=""/>
          <p:cNvPicPr/>
          <p:nvPr/>
        </p:nvPicPr>
        <p:blipFill>
          <a:blip r:embed="rId1"/>
          <a:srcRect l="1225" t="4602" r="10724" b="2779"/>
          <a:stretch/>
        </p:blipFill>
        <p:spPr>
          <a:xfrm>
            <a:off x="146160" y="82440"/>
            <a:ext cx="6646680" cy="3962520"/>
          </a:xfrm>
          <a:prstGeom prst="rect">
            <a:avLst/>
          </a:prstGeom>
          <a:ln w="0">
            <a:noFill/>
          </a:ln>
        </p:spPr>
      </p:pic>
      <p:sp>
        <p:nvSpPr>
          <p:cNvPr id="49" name="ZoneTexte 15"/>
          <p:cNvSpPr/>
          <p:nvPr/>
        </p:nvSpPr>
        <p:spPr>
          <a:xfrm rot="16200000">
            <a:off x="-1248840" y="1495080"/>
            <a:ext cx="27367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Percentages of expressed HERV probesets (%)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3"/>
          <p:cNvSpPr/>
          <p:nvPr/>
        </p:nvSpPr>
        <p:spPr>
          <a:xfrm>
            <a:off x="5492880" y="117360"/>
            <a:ext cx="1263600" cy="86220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4"/>
          <p:cNvSpPr/>
          <p:nvPr/>
        </p:nvSpPr>
        <p:spPr>
          <a:xfrm>
            <a:off x="5586480" y="182520"/>
            <a:ext cx="129960" cy="130320"/>
          </a:xfrm>
          <a:prstGeom prst="rect">
            <a:avLst/>
          </a:prstGeom>
          <a:solidFill>
            <a:srgbClr val="99cc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15"/>
          <p:cNvSpPr/>
          <p:nvPr/>
        </p:nvSpPr>
        <p:spPr>
          <a:xfrm>
            <a:off x="5738760" y="135000"/>
            <a:ext cx="205596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Gammaretroviru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6"/>
          <p:cNvSpPr/>
          <p:nvPr/>
        </p:nvSpPr>
        <p:spPr>
          <a:xfrm>
            <a:off x="5586480" y="390600"/>
            <a:ext cx="129960" cy="127080"/>
          </a:xfrm>
          <a:prstGeom prst="rect">
            <a:avLst/>
          </a:prstGeom>
          <a:solidFill>
            <a:srgbClr val="ff9999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ZoneTexte 7"/>
          <p:cNvSpPr/>
          <p:nvPr/>
        </p:nvSpPr>
        <p:spPr>
          <a:xfrm>
            <a:off x="5751360" y="343080"/>
            <a:ext cx="187164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Betaretroviru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18"/>
          <p:cNvSpPr/>
          <p:nvPr/>
        </p:nvSpPr>
        <p:spPr>
          <a:xfrm>
            <a:off x="5586480" y="596880"/>
            <a:ext cx="129960" cy="127080"/>
          </a:xfrm>
          <a:prstGeom prst="rect">
            <a:avLst/>
          </a:prstGeom>
          <a:solidFill>
            <a:srgbClr val="33cccc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ZoneTexte 11"/>
          <p:cNvSpPr/>
          <p:nvPr/>
        </p:nvSpPr>
        <p:spPr>
          <a:xfrm>
            <a:off x="5737320" y="541440"/>
            <a:ext cx="199692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Spuma-Epsilon lik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20"/>
          <p:cNvSpPr/>
          <p:nvPr/>
        </p:nvSpPr>
        <p:spPr>
          <a:xfrm>
            <a:off x="5586480" y="785880"/>
            <a:ext cx="129960" cy="129960"/>
          </a:xfrm>
          <a:prstGeom prst="rect">
            <a:avLst/>
          </a:prstGeom>
          <a:solidFill>
            <a:srgbClr val="cc99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ZoneTexte 13"/>
          <p:cNvSpPr/>
          <p:nvPr/>
        </p:nvSpPr>
        <p:spPr>
          <a:xfrm>
            <a:off x="5751360" y="735120"/>
            <a:ext cx="209556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Others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22"/>
          <p:cNvSpPr/>
          <p:nvPr/>
        </p:nvSpPr>
        <p:spPr>
          <a:xfrm>
            <a:off x="30240" y="39600"/>
            <a:ext cx="6804000" cy="4032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7T13:18:57Z</dcterms:created>
  <dc:creator>MOMMERT Marine</dc:creator>
  <dc:description/>
  <dc:language>en-US</dc:language>
  <cp:lastModifiedBy>MOMMERT Marine</cp:lastModifiedBy>
  <dcterms:modified xsi:type="dcterms:W3CDTF">2019-10-02T14:56:07Z</dcterms:modified>
  <cp:revision>1</cp:revision>
  <dc:subject/>
  <dc:title>Présentation PowerPoint</dc:title>
</cp:coreProperties>
</file>